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53" y="50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0A1695-2818-4564-A540-76EA8D5089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942813B-AFB4-46D6-B0F5-A24B974078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61CFC8-A103-4888-A42F-6828FEC02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E46E3B-0D14-417F-B1DC-4E1C03AA7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C1151E7-35ED-446B-A37D-CBCDC6B68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0914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47976AF-44EB-40BB-953B-7D6704F5D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CC4F1B4-B90A-4643-A5A1-4DFD10A6A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D9CD7A6-D7B2-4CF2-AAD3-84919BCCB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DCAFE7-883A-4802-8044-6781532AC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8518534-F1E3-4D87-9CE2-368ECEF32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866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B15FFC8-F58D-4872-8E29-A674FD0677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0AA7CCD-5B97-438E-9251-9564484271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395D5F6-EA67-45FB-9760-2A0A06D22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BD658CC-966F-44E1-B6AA-888B2D6FA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5D593FA-B986-4B7C-B0D4-B43977F4B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670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85B9122-EF78-4500-B90B-25ECE73783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DA422A1-B5A8-4B94-BDCA-6AFA810CE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A69513B-46E4-480B-A399-3F3117074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8897320-CFA3-48EB-9A4F-E8C6159E5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DD5D7B8-C55F-480C-9909-8FD3A5329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319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F73D47-4352-4285-948D-8AB153B77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4695981-0704-4B17-91B3-C80169E884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1118D96-7FAF-499D-81E3-755B407EE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2BCB5B-AD0B-45D7-91F1-39ADC7051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02B46B-6FCF-48D7-AD31-711AFAB76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9060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14739BC-CA16-4B79-9B1F-D0E182321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225EFA3-CEF0-4F4A-9BF5-46B45162E8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C20EB2E-5360-44BC-8629-291FD11196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EAA9AF8-D542-4C5A-88A5-1CC6B0A78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723B561-7D6E-47FC-A862-2587DCAD5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06405D-248A-417A-BD98-97D47DCA1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215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B6FF228-B529-474E-86F9-15F7CCE4A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370682A-6EA6-49D5-93E4-B85E35FD48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B92A21A-065B-4B06-B01E-75FF1F84C6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4EB6EC0-37A3-44FD-8279-366052C93D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ED49082-D8AD-4ED0-AF2B-CCC425D302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8113AC2-EDC6-4768-A5F2-3BC745DFB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D59565B8-F066-4332-88E2-06B4E360B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EC6769A-ADFD-4BF6-8589-C87A05244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6622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5C121E-727F-48BE-B826-AA48C3F55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09B3D69D-1A26-40E3-B7A8-0EBC04144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75DB269-13F9-430C-97F4-3BE6F82BC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CE74D16-9BA0-4B0B-8031-2B2BA8821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5355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7F73329-CD01-4C0D-9CB9-55DB1C5EE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B55DA93-0865-4E45-930E-8414AB00E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4AAC914-5E02-418A-AC01-E5618F4F7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2856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986ED2-62E1-4CAD-8320-BFD27478A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9F16A56-05E6-41B9-8AAB-9DC86310D7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DD991B4-63AA-476C-9F23-A10427B2AC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D26164B-A30C-4193-A860-4C326F1CC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272055C-9D40-4B91-A234-D7AEE0AEE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BC947CD-1955-4650-9E3B-551BC095A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5513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1F3B15-3AB9-4605-839C-15A799802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DCA0F59-AE0E-4CD0-9EB1-B2E0EA1177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E9112F1-44CB-442A-8477-298ED5EEE4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EAC6B63-D93A-4DDD-B56A-B0B7A6DE4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28EF7A7-1256-4CC3-8D07-D7A12888A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B0D4E41-9901-44D3-BD66-705052973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947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4E82FAA-1496-4085-96E9-768D5B711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9C71CAE-10E9-4029-90B4-743BF6E52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071CEC3-A6E3-4389-A0FC-4240844DA4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123183-A525-4852-9D72-77F459FFBADC}" type="datetimeFigureOut">
              <a:rPr lang="ko-KR" altLang="en-US" smtClean="0"/>
              <a:t>2024-10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9AF4EA3-D8D5-45D7-806F-061455805B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8BB2F3B-4C46-49AA-BAB1-C368FD1285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4A87A-3FC9-4FBB-B5D1-47FA049A1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6388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1D2584F-698A-4136-9A72-8D990051100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2" t="4167" r="34369" b="4445"/>
          <a:stretch/>
        </p:blipFill>
        <p:spPr>
          <a:xfrm>
            <a:off x="207031" y="403186"/>
            <a:ext cx="5095914" cy="537357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1F93FFA3-EE74-4C89-A2ED-BEA92341048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7" t="3168" r="29057" b="4026"/>
          <a:stretch/>
        </p:blipFill>
        <p:spPr>
          <a:xfrm>
            <a:off x="7090290" y="409309"/>
            <a:ext cx="4960812" cy="537357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75DADA2-04E0-4B4D-9924-E27479A13FD7}"/>
              </a:ext>
            </a:extLst>
          </p:cNvPr>
          <p:cNvSpPr txBox="1"/>
          <p:nvPr/>
        </p:nvSpPr>
        <p:spPr>
          <a:xfrm>
            <a:off x="65435" y="139441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4360D46-33FF-401E-A972-B77729CB7147}"/>
              </a:ext>
            </a:extLst>
          </p:cNvPr>
          <p:cNvSpPr txBox="1"/>
          <p:nvPr/>
        </p:nvSpPr>
        <p:spPr>
          <a:xfrm>
            <a:off x="7016149" y="139441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B505E6-2018-47CC-8C95-27D9CBBA6EA5}"/>
              </a:ext>
            </a:extLst>
          </p:cNvPr>
          <p:cNvSpPr txBox="1"/>
          <p:nvPr/>
        </p:nvSpPr>
        <p:spPr>
          <a:xfrm>
            <a:off x="617103" y="6011162"/>
            <a:ext cx="1113005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Top networks of differentially expressed mRNAs (DEmRNAs) the during the proliferative and secretory phases of the menstrual cycle, as identified using the Ingenuity Pathway Analysis (IPA) software (version 122103623; QIAGEN, Hilden, Germany). (</a:t>
            </a: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) The top network of DEmRNAs in the proliferative-phase control (pCT) group compared with the secretory control (sCT) group. (</a:t>
            </a: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) The top network of DEmRNAs in the proliferative endometriosis (pEMS) group compared with the secretory endometriosis (sEMS) group. An asterisk indicates that multiple identifiers in the dataset file map to a single gene or chemical in the Global Molecular Network.</a:t>
            </a:r>
            <a:endParaRPr lang="ko-KR" altLang="en-US" sz="10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5517BB96-6CF6-4BFA-92F5-5D59CE1224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40289" y="377728"/>
            <a:ext cx="1694303" cy="54005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904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26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joumc</dc:creator>
  <cp:lastModifiedBy>ajoumc</cp:lastModifiedBy>
  <cp:revision>7</cp:revision>
  <dcterms:created xsi:type="dcterms:W3CDTF">2023-09-21T11:23:12Z</dcterms:created>
  <dcterms:modified xsi:type="dcterms:W3CDTF">2024-09-30T16:35:11Z</dcterms:modified>
</cp:coreProperties>
</file>